
<file path=[Content_Types].xml><?xml version="1.0" encoding="utf-8"?>
<Types xmlns="http://schemas.openxmlformats.org/package/2006/content-types">
  <Default Extension="jpeg" ContentType="image/jpeg"/>
  <Default Extension="jpg" ContentType="image/jp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FF5E0F6-1FBB-4690-847A-AD24C03DE6C7}" v="1" dt="2024-04-11T15:39:49.5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varajan,Eswaran" userId="aad2c616-30ee-4e19-a463-6aea41bf38a4" providerId="ADAL" clId="{4B2AF3FE-C1C0-47B9-AD34-2329D6B9FA12}"/>
    <pc:docChg chg="modSld">
      <pc:chgData name="Devarajan,Eswaran" userId="aad2c616-30ee-4e19-a463-6aea41bf38a4" providerId="ADAL" clId="{4B2AF3FE-C1C0-47B9-AD34-2329D6B9FA12}" dt="2023-05-08T19:29:45.161" v="7" actId="20577"/>
      <pc:docMkLst>
        <pc:docMk/>
      </pc:docMkLst>
      <pc:sldChg chg="modSp">
        <pc:chgData name="Devarajan,Eswaran" userId="aad2c616-30ee-4e19-a463-6aea41bf38a4" providerId="ADAL" clId="{4B2AF3FE-C1C0-47B9-AD34-2329D6B9FA12}" dt="2023-05-08T19:29:45.161" v="7" actId="20577"/>
        <pc:sldMkLst>
          <pc:docMk/>
          <pc:sldMk cId="0" sldId="259"/>
        </pc:sldMkLst>
        <pc:spChg chg="mod">
          <ac:chgData name="Devarajan,Eswaran" userId="aad2c616-30ee-4e19-a463-6aea41bf38a4" providerId="ADAL" clId="{4B2AF3FE-C1C0-47B9-AD34-2329D6B9FA12}" dt="2023-05-08T19:29:34.718" v="1" actId="20577"/>
          <ac:spMkLst>
            <pc:docMk/>
            <pc:sldMk cId="0" sldId="259"/>
            <ac:spMk id="6" creationId="{00000000-0000-0000-0000-000000000000}"/>
          </ac:spMkLst>
        </pc:spChg>
        <pc:spChg chg="mod">
          <ac:chgData name="Devarajan,Eswaran" userId="aad2c616-30ee-4e19-a463-6aea41bf38a4" providerId="ADAL" clId="{4B2AF3FE-C1C0-47B9-AD34-2329D6B9FA12}" dt="2023-05-08T19:29:38.094" v="3" actId="20577"/>
          <ac:spMkLst>
            <pc:docMk/>
            <pc:sldMk cId="0" sldId="259"/>
            <ac:spMk id="7" creationId="{00000000-0000-0000-0000-000000000000}"/>
          </ac:spMkLst>
        </pc:spChg>
        <pc:spChg chg="mod">
          <ac:chgData name="Devarajan,Eswaran" userId="aad2c616-30ee-4e19-a463-6aea41bf38a4" providerId="ADAL" clId="{4B2AF3FE-C1C0-47B9-AD34-2329D6B9FA12}" dt="2023-05-08T19:29:41.391" v="5" actId="20577"/>
          <ac:spMkLst>
            <pc:docMk/>
            <pc:sldMk cId="0" sldId="259"/>
            <ac:spMk id="8" creationId="{00000000-0000-0000-0000-000000000000}"/>
          </ac:spMkLst>
        </pc:spChg>
        <pc:spChg chg="mod">
          <ac:chgData name="Devarajan,Eswaran" userId="aad2c616-30ee-4e19-a463-6aea41bf38a4" providerId="ADAL" clId="{4B2AF3FE-C1C0-47B9-AD34-2329D6B9FA12}" dt="2023-05-08T19:29:45.161" v="7" actId="20577"/>
          <ac:spMkLst>
            <pc:docMk/>
            <pc:sldMk cId="0" sldId="259"/>
            <ac:spMk id="9" creationId="{00000000-0000-0000-0000-000000000000}"/>
          </ac:spMkLst>
        </pc:spChg>
      </pc:sldChg>
    </pc:docChg>
  </pc:docChgLst>
  <pc:docChgLst>
    <pc:chgData name="Devarajan,Eswaran" userId="aad2c616-30ee-4e19-a463-6aea41bf38a4" providerId="ADAL" clId="{1E2A8522-95F5-4A62-A70F-E8B6028953FA}"/>
    <pc:docChg chg="modSld">
      <pc:chgData name="Devarajan,Eswaran" userId="aad2c616-30ee-4e19-a463-6aea41bf38a4" providerId="ADAL" clId="{1E2A8522-95F5-4A62-A70F-E8B6028953FA}" dt="2023-10-26T15:18:33.645" v="7" actId="20577"/>
      <pc:docMkLst>
        <pc:docMk/>
      </pc:docMkLst>
      <pc:sldChg chg="modSp">
        <pc:chgData name="Devarajan,Eswaran" userId="aad2c616-30ee-4e19-a463-6aea41bf38a4" providerId="ADAL" clId="{1E2A8522-95F5-4A62-A70F-E8B6028953FA}" dt="2023-10-26T15:18:33.645" v="7" actId="20577"/>
        <pc:sldMkLst>
          <pc:docMk/>
          <pc:sldMk cId="0" sldId="259"/>
        </pc:sldMkLst>
        <pc:spChg chg="mod">
          <ac:chgData name="Devarajan,Eswaran" userId="aad2c616-30ee-4e19-a463-6aea41bf38a4" providerId="ADAL" clId="{1E2A8522-95F5-4A62-A70F-E8B6028953FA}" dt="2023-10-26T15:18:23.106" v="1" actId="20577"/>
          <ac:spMkLst>
            <pc:docMk/>
            <pc:sldMk cId="0" sldId="259"/>
            <ac:spMk id="6" creationId="{00000000-0000-0000-0000-000000000000}"/>
          </ac:spMkLst>
        </pc:spChg>
        <pc:spChg chg="mod">
          <ac:chgData name="Devarajan,Eswaran" userId="aad2c616-30ee-4e19-a463-6aea41bf38a4" providerId="ADAL" clId="{1E2A8522-95F5-4A62-A70F-E8B6028953FA}" dt="2023-10-26T15:18:26.456" v="3" actId="20577"/>
          <ac:spMkLst>
            <pc:docMk/>
            <pc:sldMk cId="0" sldId="259"/>
            <ac:spMk id="7" creationId="{00000000-0000-0000-0000-000000000000}"/>
          </ac:spMkLst>
        </pc:spChg>
        <pc:spChg chg="mod">
          <ac:chgData name="Devarajan,Eswaran" userId="aad2c616-30ee-4e19-a463-6aea41bf38a4" providerId="ADAL" clId="{1E2A8522-95F5-4A62-A70F-E8B6028953FA}" dt="2023-10-26T15:18:29.660" v="5" actId="20577"/>
          <ac:spMkLst>
            <pc:docMk/>
            <pc:sldMk cId="0" sldId="259"/>
            <ac:spMk id="8" creationId="{00000000-0000-0000-0000-000000000000}"/>
          </ac:spMkLst>
        </pc:spChg>
        <pc:spChg chg="mod">
          <ac:chgData name="Devarajan,Eswaran" userId="aad2c616-30ee-4e19-a463-6aea41bf38a4" providerId="ADAL" clId="{1E2A8522-95F5-4A62-A70F-E8B6028953FA}" dt="2023-10-26T15:18:33.645" v="7" actId="20577"/>
          <ac:spMkLst>
            <pc:docMk/>
            <pc:sldMk cId="0" sldId="259"/>
            <ac:spMk id="9" creationId="{00000000-0000-0000-0000-000000000000}"/>
          </ac:spMkLst>
        </pc:spChg>
      </pc:sldChg>
    </pc:docChg>
  </pc:docChgLst>
  <pc:docChgLst>
    <pc:chgData name="Eswaran Devarajan" userId="aad2c616-30ee-4e19-a463-6aea41bf38a4" providerId="ADAL" clId="{19E226A7-7136-4429-B32D-31EDF9BD402A}"/>
    <pc:docChg chg="modSld">
      <pc:chgData name="Eswaran Devarajan" userId="aad2c616-30ee-4e19-a463-6aea41bf38a4" providerId="ADAL" clId="{19E226A7-7136-4429-B32D-31EDF9BD402A}" dt="2023-04-10T19:55:30.494" v="7" actId="20577"/>
      <pc:docMkLst>
        <pc:docMk/>
      </pc:docMkLst>
      <pc:sldChg chg="modSp">
        <pc:chgData name="Eswaran Devarajan" userId="aad2c616-30ee-4e19-a463-6aea41bf38a4" providerId="ADAL" clId="{19E226A7-7136-4429-B32D-31EDF9BD402A}" dt="2023-04-10T19:55:30.494" v="7" actId="20577"/>
        <pc:sldMkLst>
          <pc:docMk/>
          <pc:sldMk cId="0" sldId="259"/>
        </pc:sldMkLst>
        <pc:spChg chg="mod">
          <ac:chgData name="Eswaran Devarajan" userId="aad2c616-30ee-4e19-a463-6aea41bf38a4" providerId="ADAL" clId="{19E226A7-7136-4429-B32D-31EDF9BD402A}" dt="2023-04-10T19:55:19.670" v="1" actId="20577"/>
          <ac:spMkLst>
            <pc:docMk/>
            <pc:sldMk cId="0" sldId="259"/>
            <ac:spMk id="6" creationId="{00000000-0000-0000-0000-000000000000}"/>
          </ac:spMkLst>
        </pc:spChg>
        <pc:spChg chg="mod">
          <ac:chgData name="Eswaran Devarajan" userId="aad2c616-30ee-4e19-a463-6aea41bf38a4" providerId="ADAL" clId="{19E226A7-7136-4429-B32D-31EDF9BD402A}" dt="2023-04-10T19:55:23.422" v="3" actId="20577"/>
          <ac:spMkLst>
            <pc:docMk/>
            <pc:sldMk cId="0" sldId="259"/>
            <ac:spMk id="7" creationId="{00000000-0000-0000-0000-000000000000}"/>
          </ac:spMkLst>
        </pc:spChg>
        <pc:spChg chg="mod">
          <ac:chgData name="Eswaran Devarajan" userId="aad2c616-30ee-4e19-a463-6aea41bf38a4" providerId="ADAL" clId="{19E226A7-7136-4429-B32D-31EDF9BD402A}" dt="2023-04-10T19:55:27.380" v="5" actId="20577"/>
          <ac:spMkLst>
            <pc:docMk/>
            <pc:sldMk cId="0" sldId="259"/>
            <ac:spMk id="8" creationId="{00000000-0000-0000-0000-000000000000}"/>
          </ac:spMkLst>
        </pc:spChg>
        <pc:spChg chg="mod">
          <ac:chgData name="Eswaran Devarajan" userId="aad2c616-30ee-4e19-a463-6aea41bf38a4" providerId="ADAL" clId="{19E226A7-7136-4429-B32D-31EDF9BD402A}" dt="2023-04-10T19:55:30.494" v="7" actId="20577"/>
          <ac:spMkLst>
            <pc:docMk/>
            <pc:sldMk cId="0" sldId="259"/>
            <ac:spMk id="9" creationId="{00000000-0000-0000-0000-000000000000}"/>
          </ac:spMkLst>
        </pc:spChg>
      </pc:sldChg>
    </pc:docChg>
  </pc:docChgLst>
  <pc:docChgLst>
    <pc:chgData name="Devarajan,Eswaran" userId="aad2c616-30ee-4e19-a463-6aea41bf38a4" providerId="ADAL" clId="{0FF5E0F6-1FBB-4690-847A-AD24C03DE6C7}"/>
    <pc:docChg chg="modSld">
      <pc:chgData name="Devarajan,Eswaran" userId="aad2c616-30ee-4e19-a463-6aea41bf38a4" providerId="ADAL" clId="{0FF5E0F6-1FBB-4690-847A-AD24C03DE6C7}" dt="2024-04-11T15:40:00.248" v="4" actId="255"/>
      <pc:docMkLst>
        <pc:docMk/>
      </pc:docMkLst>
      <pc:sldChg chg="addSp modSp mod">
        <pc:chgData name="Devarajan,Eswaran" userId="aad2c616-30ee-4e19-a463-6aea41bf38a4" providerId="ADAL" clId="{0FF5E0F6-1FBB-4690-847A-AD24C03DE6C7}" dt="2024-04-11T15:40:00.248" v="4" actId="255"/>
        <pc:sldMkLst>
          <pc:docMk/>
          <pc:sldMk cId="0" sldId="259"/>
        </pc:sldMkLst>
        <pc:spChg chg="add mod">
          <ac:chgData name="Devarajan,Eswaran" userId="aad2c616-30ee-4e19-a463-6aea41bf38a4" providerId="ADAL" clId="{0FF5E0F6-1FBB-4690-847A-AD24C03DE6C7}" dt="2024-04-11T15:40:00.248" v="4" actId="255"/>
          <ac:spMkLst>
            <pc:docMk/>
            <pc:sldMk cId="0" sldId="259"/>
            <ac:spMk id="11" creationId="{DE06432B-1485-3782-C3B7-94949168BBD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03DCA-F6DF-4060-8439-5DF8A5C733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24E309-382D-42DD-894C-DA1DFB3F48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247002-EF76-4056-A06F-E54A857F0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715806-2FE8-4F0F-A50C-6FB3AFAA6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EC7787-E06F-4047-87C0-36A27A811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093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5C93EC-8A13-4C76-9297-D3D58EDBE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84D2B9-FFB4-4871-97BA-5431F40237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D5D75B-52EB-49A2-87F7-B7DC8AEE2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06F320-7A5B-456A-AE77-0C221C184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BBEB8-7F16-417C-9909-49E143963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180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6B1D71-65CC-45E2-AA33-981E0EDC5E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37AD29-5530-4D08-95B6-B87011A1CC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2F2C73-8AE2-4C96-BF03-9287748B1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C9E5DF-4B70-44C5-B43E-8541B4357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51E24F-90B6-47C3-84CD-C295F12AE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718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200DDF-67BA-47B6-ABDB-43B869502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93E0B8-BD9B-4403-80D0-CB4C8B4F61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D75307-7673-404B-84E4-234203190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0571A-BF92-47A2-97DE-EDD4B2D7A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3F3326-29CC-49BD-A9BC-C209867A8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017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8066EE-F2AC-40DE-AA09-E7CD9A8C7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F0A015-C8E9-4575-963D-D22CD1110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A5243E-9EEF-44D5-B609-5F25DA12F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D8CCC-6F9B-4669-8456-A644B984D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7329D3-AA4D-415C-A4FA-B939FD3B0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328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AC1D95-CC73-4AA1-B38C-6F99DA1E1F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3812F3-030D-4AB8-8398-E96E855998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7A6912-023F-488C-AEE4-4147685268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55EA33-70F3-4B41-8A55-156770E61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CB332E-1C8B-48E3-9E33-5BBD9C444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DF3AAD-F1B2-415C-84B6-813B4C4EE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064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A869B6-4879-4C71-9477-0A7462DECB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82173E-C777-45E0-AC62-D1D1E23BA4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047897-EC35-4B99-87A3-EF55A8E14F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13DEFCB-F1B8-46EB-B15F-8C1AD956A8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779477-E6FA-478B-8047-76E87E1136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BD30B3-4564-4FF0-8CA4-73BAF2F27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92EDF06-8370-4094-978C-160C3925C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7DBAE1-4C68-47FB-8D76-258EC6196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30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0A2F8-AB9D-4D3E-89FC-69C810789A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9EDC3C-93A1-4706-9F1E-91680243B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E3A8DA-CBE5-4A60-9614-BDDA1A3B0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473C06-03D3-44C8-888D-A7FC74DBE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32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22CC89-F842-48F3-9498-97AB2DDE7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5FFEDD-E061-405A-A2A1-D97E1A395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2E8375-EAB9-449A-86CD-B8A4C0DED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77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FDCC7F-C420-4158-9E15-63626E4C0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E6E8DC-8F4A-448E-B929-791C8D6815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9D1BE7-F0EF-4BCD-8731-EC8CEF5087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5F697E-D3EB-4735-93A1-5252286FF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CC85A6-AC51-49B4-BCFB-4D5DF500D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3A4153-10FF-4173-8098-97D2C2E51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69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D83C1-AA73-4C19-8049-954679C5B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E4A1A9-41BC-42D4-9559-245DA67530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B4B165-5A7A-43E0-8092-9E882F1CAD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D9C9E9-B840-4832-ABA0-953649FE4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D935BE-0D00-4D46-952B-4913BB47C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E26F66-DD14-4B6B-A171-75414C10F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325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7ECFF2-B999-4A34-9CC7-F1A8FC6AA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02F6F2-C1D2-4BF9-B903-4B9BF2E13A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AAAB26-39FC-49AF-896D-CEC267DA30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F8F56-B216-476B-B4A6-1CFADED665F6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FD5E54-7F01-4264-B546-EB31C11403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7DEC1D-AC92-4C27-A2D5-FC08A8E6F7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A1F22E-9A6B-4023-8C9D-66D3D601E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740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311146" y="927353"/>
            <a:ext cx="3532631" cy="2374391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935979" y="927353"/>
            <a:ext cx="3525773" cy="236981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2311145" y="3403853"/>
            <a:ext cx="3514343" cy="2362199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5921502" y="3403853"/>
            <a:ext cx="3513580" cy="2362199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/>
          <p:nvPr/>
        </p:nvSpPr>
        <p:spPr>
          <a:xfrm>
            <a:off x="2440939" y="996441"/>
            <a:ext cx="16446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b="1" dirty="0">
                <a:latin typeface="Calibri"/>
                <a:cs typeface="Calibri"/>
              </a:rPr>
              <a:t>a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6051448" y="996441"/>
            <a:ext cx="15367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b="1" dirty="0">
                <a:latin typeface="Calibri"/>
                <a:cs typeface="Calibri"/>
              </a:rPr>
              <a:t>b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440939" y="3461207"/>
            <a:ext cx="14668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b="1" dirty="0">
                <a:latin typeface="Calibri"/>
                <a:cs typeface="Calibri"/>
              </a:rPr>
              <a:t>c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6046647" y="3461207"/>
            <a:ext cx="16954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b="1" dirty="0">
                <a:latin typeface="Calibri"/>
                <a:cs typeface="Calibri"/>
              </a:rPr>
              <a:t>d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10" name="TextBox 89">
            <a:extLst>
              <a:ext uri="{FF2B5EF4-FFF2-40B4-BE49-F238E27FC236}">
                <a16:creationId xmlns:a16="http://schemas.microsoft.com/office/drawing/2014/main" id="{96CB5D5F-F477-4FC8-BA50-0BE372364FAC}"/>
              </a:ext>
            </a:extLst>
          </p:cNvPr>
          <p:cNvSpPr txBox="1"/>
          <p:nvPr/>
        </p:nvSpPr>
        <p:spPr>
          <a:xfrm>
            <a:off x="966807" y="375300"/>
            <a:ext cx="104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igure.S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06432B-1485-3782-C3B7-94949168BBDB}"/>
              </a:ext>
            </a:extLst>
          </p:cNvPr>
          <p:cNvSpPr txBox="1"/>
          <p:nvPr/>
        </p:nvSpPr>
        <p:spPr>
          <a:xfrm>
            <a:off x="492930" y="6068768"/>
            <a:ext cx="10780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Examples of IL-11 labeling intensity in osteosarcoma patient tumor samples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None. (b) Weak. (c) Moderate. (d) Strong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varajan,Eswaran</dc:creator>
  <cp:lastModifiedBy>Devarajan,Eswaran</cp:lastModifiedBy>
  <cp:revision>4</cp:revision>
  <dcterms:created xsi:type="dcterms:W3CDTF">2022-11-10T17:08:54Z</dcterms:created>
  <dcterms:modified xsi:type="dcterms:W3CDTF">2024-04-11T15:40:02Z</dcterms:modified>
</cp:coreProperties>
</file>